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4" d="100"/>
          <a:sy n="74" d="100"/>
        </p:scale>
        <p:origin x="84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2D439C-F20C-4F2F-9BDF-51DCACC51AE1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84E3C1-4A8B-4837-A83D-B51F8E477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739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raph that can be edit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6FB99C-404C-41CA-BCBA-0143C83D6BB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2672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906637-E35B-4434-BBD6-AF2387D4EC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B688B4-26D7-4D8C-A3A9-CBFA445D18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2D9FD1-299C-4D1D-8306-EBE9A9A66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9D6549-BD70-4534-AB9D-F7F2AC873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90DD44-9D7B-408F-95B7-B5A69D51A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217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39B70F-375D-4FDA-A605-082EB9A1B4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EB690D-4DCB-4F19-8064-24ED0F51A6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3B86F3-C256-48DD-9C6D-161D4DD85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2F27A9-69E5-455F-BC16-BFC6DB2AE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985A4F-8A30-404F-A072-37680134E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444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77C7BF-C114-43EA-85AD-51A76CDD5A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7C214B-C048-47FB-9176-4BEBC5A491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F56CDA-B872-4C7A-A23F-DD416373B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32B40E-7AB7-4206-A6B7-F3ECEDCD3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616D74-312C-4AE3-9B2D-3E9027BD2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974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9877FF-8B89-4292-B665-C9AFC12174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DC58B5-5A20-4927-827C-6AB23DA141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9B022A-456C-4EBE-A2B4-9EC049FB3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8D0BC8-181D-493A-B18E-B01E42C08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17458B-5548-403F-A912-DB377EEEA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352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B32E19-27C7-4E39-810E-17FA31E59B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526573-5028-43A4-AAF9-5BF49B4AFC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0E47DE-2EA0-4EDE-8652-F42451F52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D811EC-EB9A-4C88-BAA7-CE978CCDA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20E71A-7A44-4433-BE2F-E3BF1A570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332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87B212-076E-43D2-BA73-2B6A9DB555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9AB7FE-9887-4D20-AFE8-F617DB4292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9957BA-288D-4402-B865-31CADDACCE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3B15D6-0B7D-4A53-B652-83ECB3FCE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E24C27-97B1-4904-80BA-570446404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DC899A-7BA4-4AB5-8C55-853923E1F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088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9F00D3-9D51-49FC-962E-DE818DC4E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42130F-AE3F-4906-9843-A6886CA06E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A7991B-586A-4916-A19C-2AE52C5983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4E4F093-04AB-4CCD-80A0-216629B489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B8EA-C650-4DA6-BB96-924552FCCA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8BDD46-BAAD-475F-A8C3-64B98FEBE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B9C7EEE-74BB-44F8-9A58-C783436BD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59DC5A-3601-4142-A3CC-259167EE7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224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4B85FD-00B8-4F4C-B9E7-387E6A08EE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35F8C6-581E-43D6-BD2E-DFFA1DE673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057F2EF-21E3-44F2-85DF-8F5441D64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9642E3-3C69-4F96-A151-1AB471FE0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685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E3F4F7-98A9-4D50-8910-D811C19929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47D3E7-1166-45E0-A3DA-391A0C7C4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322ED4-A655-41B8-9144-ADB772452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349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E4D25-3416-42D3-B1B0-1ACDB451CE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1EB610-2DE7-459D-80EE-DFEC2D5651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DF7D0F-638B-4789-8AA6-F8926C9A05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98B5C9-1638-4FF3-AE5D-C7CFB9A0F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01E541-D3A4-401C-843E-D4C04B54D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B63833-D345-49E6-B5EC-94D2C75D8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39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5B500A-F1D9-48DD-8ABF-914E323B2F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0C95B0-C52A-4F20-8FDF-08B9F2DD80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D09497-8905-4968-AE73-7842212510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F3B658-24E8-412F-8A7F-C134185F0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35420D-A441-4EDF-B025-A543C36B3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C1FBB2-D718-4805-BC98-B1344526A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344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F77EB2-F1BE-4A6C-A339-6BC28459C2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D73962-51A0-4A0D-894B-FC8725774A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0F020B-1AE3-4B8F-BE66-EC0073FEF0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ED3455-4627-4954-BEF2-66FB42FCE394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3627EA-0638-4327-BCA9-4C1304A04E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590750-5F54-44E5-9077-E04CE63C85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19C9ED-6F78-4DEC-B131-C0CE18ECE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99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20C46964-CDDD-4901-B3FC-805FCC2C238D}"/>
              </a:ext>
            </a:extLst>
          </p:cNvPr>
          <p:cNvGraphicFramePr>
            <a:graphicFrameLocks noGrp="1"/>
          </p:cNvGraphicFramePr>
          <p:nvPr/>
        </p:nvGraphicFramePr>
        <p:xfrm>
          <a:off x="1904999" y="152400"/>
          <a:ext cx="7848601" cy="626778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74960">
                  <a:extLst>
                    <a:ext uri="{9D8B030D-6E8A-4147-A177-3AD203B41FA5}">
                      <a16:colId xmlns:a16="http://schemas.microsoft.com/office/drawing/2014/main" val="1385894392"/>
                    </a:ext>
                  </a:extLst>
                </a:gridCol>
                <a:gridCol w="953842">
                  <a:extLst>
                    <a:ext uri="{9D8B030D-6E8A-4147-A177-3AD203B41FA5}">
                      <a16:colId xmlns:a16="http://schemas.microsoft.com/office/drawing/2014/main" val="492583243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3455005865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1072302555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2198399910"/>
                    </a:ext>
                  </a:extLst>
                </a:gridCol>
                <a:gridCol w="1600199">
                  <a:extLst>
                    <a:ext uri="{9D8B030D-6E8A-4147-A177-3AD203B41FA5}">
                      <a16:colId xmlns:a16="http://schemas.microsoft.com/office/drawing/2014/main" val="2706170410"/>
                    </a:ext>
                  </a:extLst>
                </a:gridCol>
              </a:tblGrid>
              <a:tr h="701040">
                <a:tc>
                  <a:txBody>
                    <a:bodyPr/>
                    <a:lstStyle/>
                    <a:p>
                      <a:pPr algn="ctr"/>
                      <a:endParaRPr lang="en-US" b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b="1" dirty="0"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chemeClr val="tx1"/>
                          </a:solidFill>
                          <a:effectLst/>
                        </a:rPr>
                        <a:t>G5 CRISPR/Cas9 RNP</a:t>
                      </a:r>
                    </a:p>
                    <a:p>
                      <a:pPr algn="ctr"/>
                      <a:endParaRPr lang="en-US" b="1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chemeClr val="tx1"/>
                          </a:solidFill>
                          <a:effectLst/>
                        </a:rPr>
                        <a:t>G5 CRISPR/Cas9 RN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chemeClr val="tx1"/>
                          </a:solidFill>
                          <a:effectLst/>
                        </a:rPr>
                        <a:t>G10 CRISPR/Cas9 RN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solidFill>
                            <a:schemeClr val="tx1"/>
                          </a:solidFill>
                        </a:rPr>
                        <a:t>G10 CRISPR/Cas9 RN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075697"/>
                  </a:ext>
                </a:extLst>
              </a:tr>
              <a:tr h="689946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Patient I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SN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HD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p53 express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HD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p53 express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1370843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5773335"/>
                  </a:ext>
                </a:extLst>
              </a:tr>
              <a:tr h="328838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T or 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6235023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1374254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0300927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T or 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7551156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9137236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9624902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6379781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4228427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1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T or 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2621352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1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0660175"/>
                  </a:ext>
                </a:extLst>
              </a:tr>
              <a:tr h="348224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/>
                        <a:t>Y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N/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60622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1104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9</Words>
  <Application>Microsoft Office PowerPoint</Application>
  <PresentationFormat>Widescreen</PresentationFormat>
  <Paragraphs>8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darai, Shirin R</dc:creator>
  <cp:lastModifiedBy>Modarai, Shirin R</cp:lastModifiedBy>
  <cp:revision>1</cp:revision>
  <dcterms:created xsi:type="dcterms:W3CDTF">2020-08-05T16:22:04Z</dcterms:created>
  <dcterms:modified xsi:type="dcterms:W3CDTF">2020-08-05T16:22:48Z</dcterms:modified>
</cp:coreProperties>
</file>